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Default Extension="png" ContentType="image/png"/>
  <Default Extension="jpg" ContentType="image/jpg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7556500" cy="10693400"/>
  <p:notesSz cx="7556500" cy="106934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Relationship Id="rId7" Type="http://schemas.openxmlformats.org/officeDocument/2006/relationships/image" Target="../media/image1.png"/><Relationship Id="rId8" Type="http://schemas.openxmlformats.org/officeDocument/2006/relationships/image" Target="../media/image2.jpg"/><Relationship Id="rId9" Type="http://schemas.openxmlformats.org/officeDocument/2006/relationships/image" Target="../media/image3.jpg"/><Relationship Id="rId10" Type="http://schemas.openxmlformats.org/officeDocument/2006/relationships/image" Target="../media/image4.jpg"/><Relationship Id="rId11" Type="http://schemas.openxmlformats.org/officeDocument/2006/relationships/image" Target="../media/image5.jpg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4795646" y="958469"/>
            <a:ext cx="114300" cy="126364"/>
          </a:xfrm>
          <a:custGeom>
            <a:avLst/>
            <a:gdLst/>
            <a:ahLst/>
            <a:cxnLst/>
            <a:rect l="l" t="t" r="r" b="b"/>
            <a:pathLst>
              <a:path w="114300" h="126365">
                <a:moveTo>
                  <a:pt x="114147" y="0"/>
                </a:moveTo>
                <a:lnTo>
                  <a:pt x="0" y="0"/>
                </a:lnTo>
                <a:lnTo>
                  <a:pt x="0" y="125755"/>
                </a:lnTo>
                <a:lnTo>
                  <a:pt x="114147" y="125755"/>
                </a:lnTo>
                <a:lnTo>
                  <a:pt x="114147" y="0"/>
                </a:lnTo>
                <a:close/>
              </a:path>
            </a:pathLst>
          </a:custGeom>
          <a:solidFill>
            <a:srgbClr val="6F9AD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844156" y="958469"/>
            <a:ext cx="114300" cy="126364"/>
          </a:xfrm>
          <a:custGeom>
            <a:avLst/>
            <a:gdLst/>
            <a:ahLst/>
            <a:cxnLst/>
            <a:rect l="l" t="t" r="r" b="b"/>
            <a:pathLst>
              <a:path w="114300" h="126365">
                <a:moveTo>
                  <a:pt x="114172" y="0"/>
                </a:moveTo>
                <a:lnTo>
                  <a:pt x="0" y="0"/>
                </a:lnTo>
                <a:lnTo>
                  <a:pt x="0" y="125755"/>
                </a:lnTo>
                <a:lnTo>
                  <a:pt x="114172" y="125755"/>
                </a:lnTo>
                <a:lnTo>
                  <a:pt x="114172" y="0"/>
                </a:lnTo>
                <a:close/>
              </a:path>
            </a:pathLst>
          </a:custGeom>
          <a:solidFill>
            <a:srgbClr val="6F6F6F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2821000" y="860818"/>
            <a:ext cx="114300" cy="126364"/>
          </a:xfrm>
          <a:custGeom>
            <a:avLst/>
            <a:gdLst/>
            <a:ahLst/>
            <a:cxnLst/>
            <a:rect l="l" t="t" r="r" b="b"/>
            <a:pathLst>
              <a:path w="114300" h="126365">
                <a:moveTo>
                  <a:pt x="114173" y="0"/>
                </a:moveTo>
                <a:lnTo>
                  <a:pt x="0" y="0"/>
                </a:lnTo>
                <a:lnTo>
                  <a:pt x="0" y="125755"/>
                </a:lnTo>
                <a:lnTo>
                  <a:pt x="114173" y="125755"/>
                </a:lnTo>
                <a:lnTo>
                  <a:pt x="114173" y="0"/>
                </a:lnTo>
                <a:close/>
              </a:path>
            </a:pathLst>
          </a:custGeom>
          <a:solidFill>
            <a:srgbClr val="F08A23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2611564" y="543141"/>
            <a:ext cx="114300" cy="126364"/>
          </a:xfrm>
          <a:custGeom>
            <a:avLst/>
            <a:gdLst/>
            <a:ahLst/>
            <a:cxnLst/>
            <a:rect l="l" t="t" r="r" b="b"/>
            <a:pathLst>
              <a:path w="114300" h="126365">
                <a:moveTo>
                  <a:pt x="114160" y="0"/>
                </a:moveTo>
                <a:lnTo>
                  <a:pt x="0" y="0"/>
                </a:lnTo>
                <a:lnTo>
                  <a:pt x="0" y="125755"/>
                </a:lnTo>
                <a:lnTo>
                  <a:pt x="114160" y="125755"/>
                </a:lnTo>
                <a:lnTo>
                  <a:pt x="114160" y="0"/>
                </a:lnTo>
                <a:close/>
              </a:path>
            </a:pathLst>
          </a:custGeom>
          <a:solidFill>
            <a:srgbClr val="EF3C24"/>
          </a:solidFill>
        </p:spPr>
        <p:txBody>
          <a:bodyPr wrap="square" lIns="0" tIns="0" rIns="0" bIns="0" rtlCol="0"/>
          <a:lstStyle/>
          <a:p/>
        </p:txBody>
      </p:sp>
      <p:pic>
        <p:nvPicPr>
          <p:cNvPr id="20" name="bg object 20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2831222" y="543716"/>
            <a:ext cx="1958403" cy="124117"/>
          </a:xfrm>
          <a:prstGeom prst="rect">
            <a:avLst/>
          </a:prstGeom>
        </p:spPr>
      </p:pic>
      <p:pic>
        <p:nvPicPr>
          <p:cNvPr id="21" name="bg object 21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4415663" y="3986581"/>
            <a:ext cx="2496058" cy="2397975"/>
          </a:xfrm>
          <a:prstGeom prst="rect">
            <a:avLst/>
          </a:prstGeom>
        </p:spPr>
      </p:pic>
      <p:pic>
        <p:nvPicPr>
          <p:cNvPr id="22" name="bg object 22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4914709" y="1195921"/>
            <a:ext cx="1357858" cy="1973046"/>
          </a:xfrm>
          <a:prstGeom prst="rect">
            <a:avLst/>
          </a:prstGeom>
        </p:spPr>
      </p:pic>
      <p:pic>
        <p:nvPicPr>
          <p:cNvPr id="23" name="bg object 23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2957150" y="1247559"/>
            <a:ext cx="1536820" cy="1961857"/>
          </a:xfrm>
          <a:prstGeom prst="rect">
            <a:avLst/>
          </a:prstGeom>
        </p:spPr>
      </p:pic>
      <p:pic>
        <p:nvPicPr>
          <p:cNvPr id="24" name="bg object 24"/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936488" y="1192195"/>
            <a:ext cx="1480909" cy="1980505"/>
          </a:xfrm>
          <a:prstGeom prst="rect">
            <a:avLst/>
          </a:prstGeom>
        </p:spPr>
      </p:pic>
      <p:sp>
        <p:nvSpPr>
          <p:cNvPr id="25" name="bg object 25"/>
          <p:cNvSpPr/>
          <p:nvPr/>
        </p:nvSpPr>
        <p:spPr>
          <a:xfrm>
            <a:off x="1313294" y="5815544"/>
            <a:ext cx="2115820" cy="0"/>
          </a:xfrm>
          <a:custGeom>
            <a:avLst/>
            <a:gdLst/>
            <a:ahLst/>
            <a:cxnLst/>
            <a:rect l="l" t="t" r="r" b="b"/>
            <a:pathLst>
              <a:path w="2115820" h="0">
                <a:moveTo>
                  <a:pt x="0" y="0"/>
                </a:moveTo>
                <a:lnTo>
                  <a:pt x="2115578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bg object 26"/>
          <p:cNvSpPr/>
          <p:nvPr/>
        </p:nvSpPr>
        <p:spPr>
          <a:xfrm>
            <a:off x="1313294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" name="bg object 27"/>
          <p:cNvSpPr/>
          <p:nvPr/>
        </p:nvSpPr>
        <p:spPr>
          <a:xfrm>
            <a:off x="1736404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" name="bg object 28"/>
          <p:cNvSpPr/>
          <p:nvPr/>
        </p:nvSpPr>
        <p:spPr>
          <a:xfrm>
            <a:off x="2159521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" name="bg object 29"/>
          <p:cNvSpPr/>
          <p:nvPr/>
        </p:nvSpPr>
        <p:spPr>
          <a:xfrm>
            <a:off x="2582641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" name="bg object 30"/>
          <p:cNvSpPr/>
          <p:nvPr/>
        </p:nvSpPr>
        <p:spPr>
          <a:xfrm>
            <a:off x="3005752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" name="bg object 31"/>
          <p:cNvSpPr/>
          <p:nvPr/>
        </p:nvSpPr>
        <p:spPr>
          <a:xfrm>
            <a:off x="3428870" y="5815544"/>
            <a:ext cx="0" cy="53340"/>
          </a:xfrm>
          <a:custGeom>
            <a:avLst/>
            <a:gdLst/>
            <a:ahLst/>
            <a:cxnLst/>
            <a:rect l="l" t="t" r="r" b="b"/>
            <a:pathLst>
              <a:path w="0" h="53339">
                <a:moveTo>
                  <a:pt x="0" y="0"/>
                </a:moveTo>
                <a:lnTo>
                  <a:pt x="0" y="5287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" name="bg object 32"/>
          <p:cNvSpPr/>
          <p:nvPr/>
        </p:nvSpPr>
        <p:spPr>
          <a:xfrm>
            <a:off x="1397914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" name="bg object 33"/>
          <p:cNvSpPr/>
          <p:nvPr/>
        </p:nvSpPr>
        <p:spPr>
          <a:xfrm>
            <a:off x="1482543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" name="bg object 34"/>
          <p:cNvSpPr/>
          <p:nvPr/>
        </p:nvSpPr>
        <p:spPr>
          <a:xfrm>
            <a:off x="1567163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" name="bg object 35"/>
          <p:cNvSpPr/>
          <p:nvPr/>
        </p:nvSpPr>
        <p:spPr>
          <a:xfrm>
            <a:off x="1651783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" name="bg object 36"/>
          <p:cNvSpPr/>
          <p:nvPr/>
        </p:nvSpPr>
        <p:spPr>
          <a:xfrm>
            <a:off x="182103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" name="bg object 37"/>
          <p:cNvSpPr/>
          <p:nvPr/>
        </p:nvSpPr>
        <p:spPr>
          <a:xfrm>
            <a:off x="1905654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" name="bg object 38"/>
          <p:cNvSpPr/>
          <p:nvPr/>
        </p:nvSpPr>
        <p:spPr>
          <a:xfrm>
            <a:off x="199027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" name="bg object 39"/>
          <p:cNvSpPr/>
          <p:nvPr/>
        </p:nvSpPr>
        <p:spPr>
          <a:xfrm>
            <a:off x="2074901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" name="bg object 40"/>
          <p:cNvSpPr/>
          <p:nvPr/>
        </p:nvSpPr>
        <p:spPr>
          <a:xfrm>
            <a:off x="2244144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" name="bg object 41"/>
          <p:cNvSpPr/>
          <p:nvPr/>
        </p:nvSpPr>
        <p:spPr>
          <a:xfrm>
            <a:off x="232877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" name="bg object 42"/>
          <p:cNvSpPr/>
          <p:nvPr/>
        </p:nvSpPr>
        <p:spPr>
          <a:xfrm>
            <a:off x="241339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" name="bg object 43"/>
          <p:cNvSpPr/>
          <p:nvPr/>
        </p:nvSpPr>
        <p:spPr>
          <a:xfrm>
            <a:off x="249801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" name="bg object 44"/>
          <p:cNvSpPr/>
          <p:nvPr/>
        </p:nvSpPr>
        <p:spPr>
          <a:xfrm>
            <a:off x="266726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" name="bg object 45"/>
          <p:cNvSpPr/>
          <p:nvPr/>
        </p:nvSpPr>
        <p:spPr>
          <a:xfrm>
            <a:off x="275188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" name="bg object 46"/>
          <p:cNvSpPr/>
          <p:nvPr/>
        </p:nvSpPr>
        <p:spPr>
          <a:xfrm>
            <a:off x="2836503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" name="bg object 47"/>
          <p:cNvSpPr/>
          <p:nvPr/>
        </p:nvSpPr>
        <p:spPr>
          <a:xfrm>
            <a:off x="292113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" name="bg object 48"/>
          <p:cNvSpPr/>
          <p:nvPr/>
        </p:nvSpPr>
        <p:spPr>
          <a:xfrm>
            <a:off x="3090373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" name="bg object 49"/>
          <p:cNvSpPr/>
          <p:nvPr/>
        </p:nvSpPr>
        <p:spPr>
          <a:xfrm>
            <a:off x="317500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" name="bg object 50"/>
          <p:cNvSpPr/>
          <p:nvPr/>
        </p:nvSpPr>
        <p:spPr>
          <a:xfrm>
            <a:off x="325962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" name="bg object 51"/>
          <p:cNvSpPr/>
          <p:nvPr/>
        </p:nvSpPr>
        <p:spPr>
          <a:xfrm>
            <a:off x="3344242" y="5815544"/>
            <a:ext cx="0" cy="26670"/>
          </a:xfrm>
          <a:custGeom>
            <a:avLst/>
            <a:gdLst/>
            <a:ahLst/>
            <a:cxnLst/>
            <a:rect l="l" t="t" r="r" b="b"/>
            <a:pathLst>
              <a:path w="0" h="26670">
                <a:moveTo>
                  <a:pt x="0" y="0"/>
                </a:moveTo>
                <a:lnTo>
                  <a:pt x="0" y="26441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" name="bg object 52"/>
          <p:cNvSpPr/>
          <p:nvPr/>
        </p:nvSpPr>
        <p:spPr>
          <a:xfrm>
            <a:off x="1313294" y="4405146"/>
            <a:ext cx="0" cy="1410970"/>
          </a:xfrm>
          <a:custGeom>
            <a:avLst/>
            <a:gdLst/>
            <a:ahLst/>
            <a:cxnLst/>
            <a:rect l="l" t="t" r="r" b="b"/>
            <a:pathLst>
              <a:path w="0" h="1410970">
                <a:moveTo>
                  <a:pt x="0" y="1410398"/>
                </a:moveTo>
                <a:lnTo>
                  <a:pt x="0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" name="bg object 53"/>
          <p:cNvSpPr/>
          <p:nvPr/>
        </p:nvSpPr>
        <p:spPr>
          <a:xfrm>
            <a:off x="1260406" y="5815544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" name="bg object 54"/>
          <p:cNvSpPr/>
          <p:nvPr/>
        </p:nvSpPr>
        <p:spPr>
          <a:xfrm>
            <a:off x="1260406" y="5533454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" name="bg object 55"/>
          <p:cNvSpPr/>
          <p:nvPr/>
        </p:nvSpPr>
        <p:spPr>
          <a:xfrm>
            <a:off x="1260406" y="5251378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" name="bg object 56"/>
          <p:cNvSpPr/>
          <p:nvPr/>
        </p:nvSpPr>
        <p:spPr>
          <a:xfrm>
            <a:off x="1260406" y="4969306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" name="bg object 57"/>
          <p:cNvSpPr/>
          <p:nvPr/>
        </p:nvSpPr>
        <p:spPr>
          <a:xfrm>
            <a:off x="1260406" y="4687233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" name="bg object 58"/>
          <p:cNvSpPr/>
          <p:nvPr/>
        </p:nvSpPr>
        <p:spPr>
          <a:xfrm>
            <a:off x="1260406" y="4405157"/>
            <a:ext cx="53340" cy="0"/>
          </a:xfrm>
          <a:custGeom>
            <a:avLst/>
            <a:gdLst/>
            <a:ahLst/>
            <a:cxnLst/>
            <a:rect l="l" t="t" r="r" b="b"/>
            <a:pathLst>
              <a:path w="53340" h="0">
                <a:moveTo>
                  <a:pt x="0" y="0"/>
                </a:moveTo>
                <a:lnTo>
                  <a:pt x="52882" y="0"/>
                </a:lnTo>
              </a:path>
            </a:pathLst>
          </a:custGeom>
          <a:ln w="18237">
            <a:solidFill>
              <a:srgbClr val="02030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" name="bg object 59"/>
          <p:cNvSpPr/>
          <p:nvPr/>
        </p:nvSpPr>
        <p:spPr>
          <a:xfrm>
            <a:off x="1334447" y="4715438"/>
            <a:ext cx="2094864" cy="1003935"/>
          </a:xfrm>
          <a:custGeom>
            <a:avLst/>
            <a:gdLst/>
            <a:ahLst/>
            <a:cxnLst/>
            <a:rect l="l" t="t" r="r" b="b"/>
            <a:pathLst>
              <a:path w="2094864" h="1003935">
                <a:moveTo>
                  <a:pt x="0" y="899121"/>
                </a:moveTo>
                <a:lnTo>
                  <a:pt x="21158" y="900264"/>
                </a:lnTo>
                <a:lnTo>
                  <a:pt x="42316" y="995489"/>
                </a:lnTo>
                <a:lnTo>
                  <a:pt x="63461" y="955535"/>
                </a:lnTo>
                <a:lnTo>
                  <a:pt x="84632" y="970813"/>
                </a:lnTo>
                <a:lnTo>
                  <a:pt x="105778" y="983716"/>
                </a:lnTo>
                <a:lnTo>
                  <a:pt x="126936" y="969632"/>
                </a:lnTo>
                <a:lnTo>
                  <a:pt x="148094" y="994321"/>
                </a:lnTo>
                <a:lnTo>
                  <a:pt x="169252" y="951991"/>
                </a:lnTo>
                <a:lnTo>
                  <a:pt x="190411" y="988415"/>
                </a:lnTo>
                <a:lnTo>
                  <a:pt x="211556" y="996657"/>
                </a:lnTo>
                <a:lnTo>
                  <a:pt x="232714" y="886180"/>
                </a:lnTo>
                <a:lnTo>
                  <a:pt x="253872" y="973175"/>
                </a:lnTo>
                <a:lnTo>
                  <a:pt x="275031" y="979030"/>
                </a:lnTo>
                <a:lnTo>
                  <a:pt x="296189" y="962583"/>
                </a:lnTo>
                <a:lnTo>
                  <a:pt x="317347" y="949655"/>
                </a:lnTo>
                <a:lnTo>
                  <a:pt x="338493" y="955535"/>
                </a:lnTo>
                <a:lnTo>
                  <a:pt x="359664" y="1003706"/>
                </a:lnTo>
                <a:lnTo>
                  <a:pt x="380796" y="1002550"/>
                </a:lnTo>
                <a:lnTo>
                  <a:pt x="401955" y="923785"/>
                </a:lnTo>
                <a:lnTo>
                  <a:pt x="423125" y="882662"/>
                </a:lnTo>
                <a:lnTo>
                  <a:pt x="444258" y="976680"/>
                </a:lnTo>
                <a:lnTo>
                  <a:pt x="465429" y="933208"/>
                </a:lnTo>
                <a:lnTo>
                  <a:pt x="486600" y="984910"/>
                </a:lnTo>
                <a:lnTo>
                  <a:pt x="507733" y="974331"/>
                </a:lnTo>
                <a:lnTo>
                  <a:pt x="528891" y="876769"/>
                </a:lnTo>
                <a:lnTo>
                  <a:pt x="550049" y="916724"/>
                </a:lnTo>
                <a:lnTo>
                  <a:pt x="571207" y="979030"/>
                </a:lnTo>
                <a:lnTo>
                  <a:pt x="592353" y="971969"/>
                </a:lnTo>
                <a:lnTo>
                  <a:pt x="613511" y="912025"/>
                </a:lnTo>
                <a:lnTo>
                  <a:pt x="634669" y="369036"/>
                </a:lnTo>
                <a:lnTo>
                  <a:pt x="655828" y="535939"/>
                </a:lnTo>
                <a:lnTo>
                  <a:pt x="676986" y="311454"/>
                </a:lnTo>
                <a:lnTo>
                  <a:pt x="698144" y="325551"/>
                </a:lnTo>
                <a:lnTo>
                  <a:pt x="719289" y="631151"/>
                </a:lnTo>
                <a:lnTo>
                  <a:pt x="740460" y="399605"/>
                </a:lnTo>
                <a:lnTo>
                  <a:pt x="761606" y="481863"/>
                </a:lnTo>
                <a:lnTo>
                  <a:pt x="782764" y="622909"/>
                </a:lnTo>
                <a:lnTo>
                  <a:pt x="803922" y="648754"/>
                </a:lnTo>
                <a:lnTo>
                  <a:pt x="825080" y="419582"/>
                </a:lnTo>
                <a:lnTo>
                  <a:pt x="846239" y="485393"/>
                </a:lnTo>
                <a:lnTo>
                  <a:pt x="867384" y="380796"/>
                </a:lnTo>
                <a:lnTo>
                  <a:pt x="888542" y="441896"/>
                </a:lnTo>
                <a:lnTo>
                  <a:pt x="909701" y="673442"/>
                </a:lnTo>
                <a:lnTo>
                  <a:pt x="930859" y="766305"/>
                </a:lnTo>
                <a:lnTo>
                  <a:pt x="952017" y="137515"/>
                </a:lnTo>
                <a:lnTo>
                  <a:pt x="973175" y="541807"/>
                </a:lnTo>
                <a:lnTo>
                  <a:pt x="994321" y="761606"/>
                </a:lnTo>
                <a:lnTo>
                  <a:pt x="1015491" y="161010"/>
                </a:lnTo>
                <a:lnTo>
                  <a:pt x="1036624" y="224485"/>
                </a:lnTo>
                <a:lnTo>
                  <a:pt x="1057795" y="18783"/>
                </a:lnTo>
                <a:lnTo>
                  <a:pt x="1078953" y="662876"/>
                </a:lnTo>
                <a:lnTo>
                  <a:pt x="1100086" y="178625"/>
                </a:lnTo>
                <a:lnTo>
                  <a:pt x="1121270" y="694613"/>
                </a:lnTo>
                <a:lnTo>
                  <a:pt x="1142403" y="530047"/>
                </a:lnTo>
                <a:lnTo>
                  <a:pt x="1163561" y="440753"/>
                </a:lnTo>
                <a:lnTo>
                  <a:pt x="1184732" y="802728"/>
                </a:lnTo>
                <a:lnTo>
                  <a:pt x="1205877" y="407822"/>
                </a:lnTo>
                <a:lnTo>
                  <a:pt x="1227035" y="478358"/>
                </a:lnTo>
                <a:lnTo>
                  <a:pt x="1248181" y="313791"/>
                </a:lnTo>
                <a:lnTo>
                  <a:pt x="1269339" y="363181"/>
                </a:lnTo>
                <a:lnTo>
                  <a:pt x="1290497" y="567677"/>
                </a:lnTo>
                <a:lnTo>
                  <a:pt x="1311656" y="272668"/>
                </a:lnTo>
                <a:lnTo>
                  <a:pt x="1332814" y="302031"/>
                </a:lnTo>
                <a:lnTo>
                  <a:pt x="1353972" y="506552"/>
                </a:lnTo>
                <a:lnTo>
                  <a:pt x="1375117" y="448970"/>
                </a:lnTo>
                <a:lnTo>
                  <a:pt x="1396288" y="622909"/>
                </a:lnTo>
                <a:lnTo>
                  <a:pt x="1417434" y="508914"/>
                </a:lnTo>
                <a:lnTo>
                  <a:pt x="1438592" y="445427"/>
                </a:lnTo>
                <a:lnTo>
                  <a:pt x="1459750" y="561784"/>
                </a:lnTo>
                <a:lnTo>
                  <a:pt x="1480908" y="381965"/>
                </a:lnTo>
                <a:lnTo>
                  <a:pt x="1502067" y="495973"/>
                </a:lnTo>
                <a:lnTo>
                  <a:pt x="1523212" y="177482"/>
                </a:lnTo>
                <a:lnTo>
                  <a:pt x="1544383" y="547700"/>
                </a:lnTo>
                <a:lnTo>
                  <a:pt x="1565529" y="272668"/>
                </a:lnTo>
                <a:lnTo>
                  <a:pt x="1586687" y="477151"/>
                </a:lnTo>
                <a:lnTo>
                  <a:pt x="1607845" y="558279"/>
                </a:lnTo>
                <a:lnTo>
                  <a:pt x="1628978" y="138671"/>
                </a:lnTo>
                <a:lnTo>
                  <a:pt x="1650161" y="222122"/>
                </a:lnTo>
                <a:lnTo>
                  <a:pt x="1671307" y="513600"/>
                </a:lnTo>
                <a:lnTo>
                  <a:pt x="1692452" y="242087"/>
                </a:lnTo>
                <a:lnTo>
                  <a:pt x="1713623" y="433666"/>
                </a:lnTo>
                <a:lnTo>
                  <a:pt x="1734769" y="450138"/>
                </a:lnTo>
                <a:lnTo>
                  <a:pt x="1755914" y="446608"/>
                </a:lnTo>
                <a:lnTo>
                  <a:pt x="1777098" y="448970"/>
                </a:lnTo>
                <a:lnTo>
                  <a:pt x="1798231" y="196278"/>
                </a:lnTo>
                <a:lnTo>
                  <a:pt x="1819389" y="0"/>
                </a:lnTo>
                <a:lnTo>
                  <a:pt x="1840560" y="247992"/>
                </a:lnTo>
                <a:lnTo>
                  <a:pt x="1861705" y="479539"/>
                </a:lnTo>
                <a:lnTo>
                  <a:pt x="1882863" y="242087"/>
                </a:lnTo>
                <a:lnTo>
                  <a:pt x="1904009" y="491274"/>
                </a:lnTo>
                <a:lnTo>
                  <a:pt x="1925180" y="229184"/>
                </a:lnTo>
                <a:lnTo>
                  <a:pt x="1946325" y="470115"/>
                </a:lnTo>
                <a:lnTo>
                  <a:pt x="1967483" y="441896"/>
                </a:lnTo>
                <a:lnTo>
                  <a:pt x="1988642" y="492455"/>
                </a:lnTo>
                <a:lnTo>
                  <a:pt x="2009800" y="322021"/>
                </a:lnTo>
                <a:lnTo>
                  <a:pt x="2030945" y="400786"/>
                </a:lnTo>
                <a:lnTo>
                  <a:pt x="2052104" y="117525"/>
                </a:lnTo>
                <a:lnTo>
                  <a:pt x="2073262" y="477151"/>
                </a:lnTo>
                <a:lnTo>
                  <a:pt x="2094420" y="417245"/>
                </a:lnTo>
              </a:path>
            </a:pathLst>
          </a:custGeom>
          <a:ln w="18237">
            <a:solidFill>
              <a:srgbClr val="3E58A8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 descr=""/>
          <p:cNvSpPr txBox="1"/>
          <p:nvPr/>
        </p:nvSpPr>
        <p:spPr>
          <a:xfrm>
            <a:off x="1262471" y="5874151"/>
            <a:ext cx="102235" cy="19050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1050" spc="15" b="1">
                <a:solidFill>
                  <a:srgbClr val="020303"/>
                </a:solidFill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3" name="object 3" descr=""/>
          <p:cNvSpPr txBox="1"/>
          <p:nvPr/>
        </p:nvSpPr>
        <p:spPr>
          <a:xfrm>
            <a:off x="1647506" y="5840446"/>
            <a:ext cx="1908810" cy="426084"/>
          </a:xfrm>
          <a:prstGeom prst="rect">
            <a:avLst/>
          </a:prstGeom>
        </p:spPr>
        <p:txBody>
          <a:bodyPr wrap="square" lIns="0" tIns="501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395"/>
              </a:spcBef>
              <a:tabLst>
                <a:tab pos="435609" algn="l"/>
                <a:tab pos="858519" algn="l"/>
                <a:tab pos="1282065" algn="l"/>
                <a:tab pos="1666875" algn="l"/>
              </a:tabLst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20</a:t>
            </a:r>
            <a:r>
              <a:rPr dirty="0" sz="1050" b="1">
                <a:solidFill>
                  <a:srgbClr val="020303"/>
                </a:solidFill>
                <a:latin typeface="Arial"/>
                <a:cs typeface="Arial"/>
              </a:rPr>
              <a:t>	</a:t>
            </a: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40</a:t>
            </a:r>
            <a:r>
              <a:rPr dirty="0" sz="1050" b="1">
                <a:solidFill>
                  <a:srgbClr val="020303"/>
                </a:solidFill>
                <a:latin typeface="Arial"/>
                <a:cs typeface="Arial"/>
              </a:rPr>
              <a:t>	</a:t>
            </a: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60</a:t>
            </a:r>
            <a:r>
              <a:rPr dirty="0" sz="1050" b="1">
                <a:solidFill>
                  <a:srgbClr val="020303"/>
                </a:solidFill>
                <a:latin typeface="Arial"/>
                <a:cs typeface="Arial"/>
              </a:rPr>
              <a:t>	</a:t>
            </a: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80</a:t>
            </a:r>
            <a:r>
              <a:rPr dirty="0" sz="1050" b="1">
                <a:solidFill>
                  <a:srgbClr val="020303"/>
                </a:solidFill>
                <a:latin typeface="Arial"/>
                <a:cs typeface="Arial"/>
              </a:rPr>
              <a:t>	</a:t>
            </a: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100</a:t>
            </a:r>
            <a:endParaRPr sz="1050">
              <a:latin typeface="Arial"/>
              <a:cs typeface="Arial"/>
            </a:endParaRPr>
          </a:p>
          <a:p>
            <a:pPr marL="428625">
              <a:lnSpc>
                <a:spcPct val="100000"/>
              </a:lnSpc>
              <a:spcBef>
                <a:spcPts val="275"/>
              </a:spcBef>
            </a:pPr>
            <a:r>
              <a:rPr dirty="0" sz="1050" spc="-10" b="1">
                <a:solidFill>
                  <a:srgbClr val="020303"/>
                </a:solidFill>
                <a:latin typeface="Arial"/>
                <a:cs typeface="Arial"/>
              </a:rPr>
              <a:t>T</a:t>
            </a:r>
            <a:r>
              <a:rPr dirty="0" sz="1100" spc="-10" b="1">
                <a:solidFill>
                  <a:srgbClr val="020303"/>
                </a:solidFill>
                <a:latin typeface="Arial"/>
                <a:cs typeface="Arial"/>
              </a:rPr>
              <a:t>ime</a:t>
            </a:r>
            <a:r>
              <a:rPr dirty="0" sz="1100" spc="-50" b="1">
                <a:solidFill>
                  <a:srgbClr val="020303"/>
                </a:solidFill>
                <a:latin typeface="Arial"/>
                <a:cs typeface="Arial"/>
              </a:rPr>
              <a:t> </a:t>
            </a:r>
            <a:r>
              <a:rPr dirty="0" sz="1100" spc="-20" b="1">
                <a:solidFill>
                  <a:srgbClr val="020303"/>
                </a:solidFill>
                <a:latin typeface="Arial"/>
                <a:cs typeface="Arial"/>
              </a:rPr>
              <a:t>(ns</a:t>
            </a:r>
            <a:r>
              <a:rPr dirty="0" sz="1050" spc="-20" b="1">
                <a:solidFill>
                  <a:srgbClr val="020303"/>
                </a:solidFill>
                <a:latin typeface="Arial"/>
                <a:cs typeface="Arial"/>
              </a:rPr>
              <a:t>)</a:t>
            </a:r>
            <a:endParaRPr sz="1050">
              <a:latin typeface="Arial"/>
              <a:cs typeface="Arial"/>
            </a:endParaRPr>
          </a:p>
        </p:txBody>
      </p:sp>
      <p:sp>
        <p:nvSpPr>
          <p:cNvPr id="4" name="object 4" descr=""/>
          <p:cNvSpPr txBox="1"/>
          <p:nvPr/>
        </p:nvSpPr>
        <p:spPr>
          <a:xfrm>
            <a:off x="1028874" y="5430380"/>
            <a:ext cx="216535" cy="47244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0.5</a:t>
            </a: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96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0.0</a:t>
            </a:r>
            <a:endParaRPr sz="1050">
              <a:latin typeface="Arial"/>
              <a:cs typeface="Arial"/>
            </a:endParaRPr>
          </a:p>
        </p:txBody>
      </p:sp>
      <p:sp>
        <p:nvSpPr>
          <p:cNvPr id="5" name="object 5" descr=""/>
          <p:cNvSpPr txBox="1"/>
          <p:nvPr/>
        </p:nvSpPr>
        <p:spPr>
          <a:xfrm>
            <a:off x="1028874" y="5148322"/>
            <a:ext cx="216535" cy="19050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1.0</a:t>
            </a:r>
            <a:endParaRPr sz="1050">
              <a:latin typeface="Arial"/>
              <a:cs typeface="Arial"/>
            </a:endParaRPr>
          </a:p>
        </p:txBody>
      </p:sp>
      <p:sp>
        <p:nvSpPr>
          <p:cNvPr id="6" name="object 6" descr=""/>
          <p:cNvSpPr txBox="1"/>
          <p:nvPr/>
        </p:nvSpPr>
        <p:spPr>
          <a:xfrm>
            <a:off x="1028874" y="4302151"/>
            <a:ext cx="216535" cy="75438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2.5</a:t>
            </a: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96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2.0</a:t>
            </a: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960"/>
              </a:spcBef>
            </a:pPr>
            <a:r>
              <a:rPr dirty="0" sz="1050" spc="-25" b="1">
                <a:solidFill>
                  <a:srgbClr val="020303"/>
                </a:solidFill>
                <a:latin typeface="Arial"/>
                <a:cs typeface="Arial"/>
              </a:rPr>
              <a:t>1.5</a:t>
            </a:r>
            <a:endParaRPr sz="1050">
              <a:latin typeface="Arial"/>
              <a:cs typeface="Arial"/>
            </a:endParaRPr>
          </a:p>
        </p:txBody>
      </p:sp>
      <p:sp>
        <p:nvSpPr>
          <p:cNvPr id="7" name="object 7" descr=""/>
          <p:cNvSpPr txBox="1"/>
          <p:nvPr/>
        </p:nvSpPr>
        <p:spPr>
          <a:xfrm>
            <a:off x="845343" y="4749880"/>
            <a:ext cx="181610" cy="64516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20" b="1">
                <a:solidFill>
                  <a:srgbClr val="020303"/>
                </a:solidFill>
                <a:latin typeface="Arial"/>
                <a:cs typeface="Arial"/>
              </a:rPr>
              <a:t>RMSD</a:t>
            </a:r>
            <a:r>
              <a:rPr dirty="0" sz="1100" spc="-75" b="1">
                <a:solidFill>
                  <a:srgbClr val="020303"/>
                </a:solidFill>
                <a:latin typeface="Arial"/>
                <a:cs typeface="Arial"/>
              </a:rPr>
              <a:t> </a:t>
            </a:r>
            <a:r>
              <a:rPr dirty="0" sz="1100" spc="-25" b="1">
                <a:solidFill>
                  <a:srgbClr val="020303"/>
                </a:solidFill>
                <a:latin typeface="Arial"/>
                <a:cs typeface="Arial"/>
              </a:rPr>
              <a:t>(Å)</a:t>
            </a:r>
            <a:endParaRPr sz="1100">
              <a:latin typeface="Arial"/>
              <a:cs typeface="Arial"/>
            </a:endParaRPr>
          </a:p>
        </p:txBody>
      </p:sp>
      <p:sp>
        <p:nvSpPr>
          <p:cNvPr id="8" name="object 8" descr=""/>
          <p:cNvSpPr txBox="1"/>
          <p:nvPr/>
        </p:nvSpPr>
        <p:spPr>
          <a:xfrm>
            <a:off x="2850765" y="5501275"/>
            <a:ext cx="335280" cy="237490"/>
          </a:xfrm>
          <a:prstGeom prst="rect">
            <a:avLst/>
          </a:prstGeom>
        </p:spPr>
        <p:txBody>
          <a:bodyPr wrap="square" lIns="0" tIns="1714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dirty="0" sz="1350" spc="-25" b="1">
                <a:solidFill>
                  <a:srgbClr val="020303"/>
                </a:solidFill>
                <a:latin typeface="Arial"/>
                <a:cs typeface="Arial"/>
              </a:rPr>
              <a:t>Y71</a:t>
            </a:r>
            <a:endParaRPr sz="1350">
              <a:latin typeface="Arial"/>
              <a:cs typeface="Arial"/>
            </a:endParaRPr>
          </a:p>
        </p:txBody>
      </p:sp>
      <p:grpSp>
        <p:nvGrpSpPr>
          <p:cNvPr id="9" name="object 9" descr=""/>
          <p:cNvGrpSpPr/>
          <p:nvPr/>
        </p:nvGrpSpPr>
        <p:grpSpPr>
          <a:xfrm>
            <a:off x="1874191" y="4448222"/>
            <a:ext cx="133985" cy="535940"/>
            <a:chOff x="1874191" y="4448222"/>
            <a:chExt cx="133985" cy="535940"/>
          </a:xfrm>
        </p:grpSpPr>
        <p:sp>
          <p:nvSpPr>
            <p:cNvPr id="10" name="object 10" descr=""/>
            <p:cNvSpPr/>
            <p:nvPr/>
          </p:nvSpPr>
          <p:spPr>
            <a:xfrm>
              <a:off x="1906888" y="4454572"/>
              <a:ext cx="38735" cy="413384"/>
            </a:xfrm>
            <a:custGeom>
              <a:avLst/>
              <a:gdLst/>
              <a:ahLst/>
              <a:cxnLst/>
              <a:rect l="l" t="t" r="r" b="b"/>
              <a:pathLst>
                <a:path w="38735" h="413385">
                  <a:moveTo>
                    <a:pt x="0" y="0"/>
                  </a:moveTo>
                  <a:lnTo>
                    <a:pt x="38722" y="413042"/>
                  </a:lnTo>
                </a:path>
              </a:pathLst>
            </a:custGeom>
            <a:ln w="12699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" name="object 11" descr=""/>
            <p:cNvSpPr/>
            <p:nvPr/>
          </p:nvSpPr>
          <p:spPr>
            <a:xfrm>
              <a:off x="1874191" y="4813762"/>
              <a:ext cx="133985" cy="170180"/>
            </a:xfrm>
            <a:custGeom>
              <a:avLst/>
              <a:gdLst/>
              <a:ahLst/>
              <a:cxnLst/>
              <a:rect l="l" t="t" r="r" b="b"/>
              <a:pathLst>
                <a:path w="133985" h="170179">
                  <a:moveTo>
                    <a:pt x="133896" y="0"/>
                  </a:moveTo>
                  <a:lnTo>
                    <a:pt x="70612" y="45135"/>
                  </a:lnTo>
                  <a:lnTo>
                    <a:pt x="0" y="12547"/>
                  </a:lnTo>
                  <a:lnTo>
                    <a:pt x="82321" y="170129"/>
                  </a:lnTo>
                  <a:lnTo>
                    <a:pt x="133896" y="0"/>
                  </a:lnTo>
                  <a:close/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2" name="object 12" descr=""/>
          <p:cNvSpPr txBox="1"/>
          <p:nvPr/>
        </p:nvSpPr>
        <p:spPr>
          <a:xfrm>
            <a:off x="1742492" y="4211027"/>
            <a:ext cx="334010" cy="237490"/>
          </a:xfrm>
          <a:prstGeom prst="rect">
            <a:avLst/>
          </a:prstGeom>
        </p:spPr>
        <p:txBody>
          <a:bodyPr wrap="square" lIns="0" tIns="1714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dirty="0" sz="1350" spc="-20" b="1">
                <a:solidFill>
                  <a:srgbClr val="020303"/>
                </a:solidFill>
                <a:latin typeface="Arial"/>
                <a:cs typeface="Arial"/>
              </a:rPr>
              <a:t>Flip</a:t>
            </a:r>
            <a:endParaRPr sz="1350">
              <a:latin typeface="Arial"/>
              <a:cs typeface="Arial"/>
            </a:endParaRPr>
          </a:p>
        </p:txBody>
      </p:sp>
      <p:sp>
        <p:nvSpPr>
          <p:cNvPr id="13" name="object 13" descr=""/>
          <p:cNvSpPr txBox="1"/>
          <p:nvPr/>
        </p:nvSpPr>
        <p:spPr>
          <a:xfrm>
            <a:off x="5403000" y="4617670"/>
            <a:ext cx="23495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ED1954"/>
                </a:solidFill>
                <a:latin typeface="Arial"/>
                <a:cs typeface="Arial"/>
              </a:rPr>
              <a:t>L56</a:t>
            </a:r>
            <a:endParaRPr sz="1000">
              <a:latin typeface="Arial"/>
              <a:cs typeface="Arial"/>
            </a:endParaRPr>
          </a:p>
        </p:txBody>
      </p:sp>
      <p:sp>
        <p:nvSpPr>
          <p:cNvPr id="14" name="object 14" descr=""/>
          <p:cNvSpPr txBox="1"/>
          <p:nvPr/>
        </p:nvSpPr>
        <p:spPr>
          <a:xfrm>
            <a:off x="5488598" y="5270323"/>
            <a:ext cx="255904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ED1954"/>
                </a:solidFill>
                <a:latin typeface="Arial"/>
                <a:cs typeface="Arial"/>
              </a:rPr>
              <a:t>D54</a:t>
            </a:r>
            <a:endParaRPr sz="1000">
              <a:latin typeface="Arial"/>
              <a:cs typeface="Arial"/>
            </a:endParaRPr>
          </a:p>
        </p:txBody>
      </p:sp>
      <p:sp>
        <p:nvSpPr>
          <p:cNvPr id="15" name="object 15" descr=""/>
          <p:cNvSpPr txBox="1"/>
          <p:nvPr/>
        </p:nvSpPr>
        <p:spPr>
          <a:xfrm>
            <a:off x="5779301" y="5378400"/>
            <a:ext cx="1797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ED1954"/>
                </a:solidFill>
                <a:latin typeface="Arial"/>
                <a:cs typeface="Arial"/>
              </a:rPr>
              <a:t>K5</a:t>
            </a:r>
            <a:endParaRPr sz="1000">
              <a:latin typeface="Arial"/>
              <a:cs typeface="Arial"/>
            </a:endParaRPr>
          </a:p>
        </p:txBody>
      </p:sp>
      <p:sp>
        <p:nvSpPr>
          <p:cNvPr id="16" name="object 16" descr=""/>
          <p:cNvSpPr txBox="1"/>
          <p:nvPr/>
        </p:nvSpPr>
        <p:spPr>
          <a:xfrm>
            <a:off x="5779301" y="4897705"/>
            <a:ext cx="2489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ED1954"/>
                </a:solidFill>
                <a:latin typeface="Arial"/>
                <a:cs typeface="Arial"/>
              </a:rPr>
              <a:t>Y71</a:t>
            </a:r>
            <a:endParaRPr sz="1000">
              <a:latin typeface="Arial"/>
              <a:cs typeface="Arial"/>
            </a:endParaRPr>
          </a:p>
        </p:txBody>
      </p:sp>
      <p:sp>
        <p:nvSpPr>
          <p:cNvPr id="17" name="object 17" descr=""/>
          <p:cNvSpPr txBox="1"/>
          <p:nvPr/>
        </p:nvSpPr>
        <p:spPr>
          <a:xfrm>
            <a:off x="1218902" y="3307120"/>
            <a:ext cx="87693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231F20"/>
                </a:solidFill>
                <a:latin typeface="Arial"/>
                <a:cs typeface="Arial"/>
              </a:rPr>
              <a:t>Site</a:t>
            </a:r>
            <a:r>
              <a:rPr dirty="0" sz="1400" spc="-80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400" spc="-10">
                <a:solidFill>
                  <a:srgbClr val="231F20"/>
                </a:solidFill>
                <a:latin typeface="Arial"/>
                <a:cs typeface="Arial"/>
              </a:rPr>
              <a:t>closed</a:t>
            </a:r>
            <a:endParaRPr sz="1400">
              <a:latin typeface="Arial"/>
              <a:cs typeface="Arial"/>
            </a:endParaRPr>
          </a:p>
        </p:txBody>
      </p:sp>
      <p:sp>
        <p:nvSpPr>
          <p:cNvPr id="18" name="object 18" descr=""/>
          <p:cNvSpPr txBox="1"/>
          <p:nvPr/>
        </p:nvSpPr>
        <p:spPr>
          <a:xfrm>
            <a:off x="3051842" y="3307120"/>
            <a:ext cx="127127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">
                <a:solidFill>
                  <a:srgbClr val="010202"/>
                </a:solidFill>
                <a:latin typeface="Arial"/>
                <a:cs typeface="Arial"/>
              </a:rPr>
              <a:t>Volume</a:t>
            </a:r>
            <a:r>
              <a:rPr dirty="0" sz="1400" spc="-6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>
                <a:solidFill>
                  <a:srgbClr val="010202"/>
                </a:solidFill>
                <a:latin typeface="Arial"/>
                <a:cs typeface="Arial"/>
              </a:rPr>
              <a:t>=</a:t>
            </a:r>
            <a:r>
              <a:rPr dirty="0" sz="1400" spc="-5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>
                <a:solidFill>
                  <a:srgbClr val="010202"/>
                </a:solidFill>
                <a:latin typeface="Arial"/>
                <a:cs typeface="Arial"/>
              </a:rPr>
              <a:t>104</a:t>
            </a:r>
            <a:r>
              <a:rPr dirty="0" sz="1400" spc="-5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 spc="-50">
                <a:solidFill>
                  <a:srgbClr val="010202"/>
                </a:solidFill>
                <a:latin typeface="Arial"/>
                <a:cs typeface="Arial"/>
              </a:rPr>
              <a:t>Å</a:t>
            </a:r>
            <a:endParaRPr sz="1400">
              <a:latin typeface="Arial"/>
              <a:cs typeface="Arial"/>
            </a:endParaRPr>
          </a:p>
        </p:txBody>
      </p:sp>
      <p:sp>
        <p:nvSpPr>
          <p:cNvPr id="19" name="object 19" descr=""/>
          <p:cNvSpPr txBox="1"/>
          <p:nvPr/>
        </p:nvSpPr>
        <p:spPr>
          <a:xfrm>
            <a:off x="4978128" y="3307120"/>
            <a:ext cx="127127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">
                <a:solidFill>
                  <a:srgbClr val="010202"/>
                </a:solidFill>
                <a:latin typeface="Arial"/>
                <a:cs typeface="Arial"/>
              </a:rPr>
              <a:t>Volume</a:t>
            </a:r>
            <a:r>
              <a:rPr dirty="0" sz="1400" spc="-6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>
                <a:solidFill>
                  <a:srgbClr val="010202"/>
                </a:solidFill>
                <a:latin typeface="Arial"/>
                <a:cs typeface="Arial"/>
              </a:rPr>
              <a:t>=</a:t>
            </a:r>
            <a:r>
              <a:rPr dirty="0" sz="1400" spc="-5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>
                <a:solidFill>
                  <a:srgbClr val="010202"/>
                </a:solidFill>
                <a:latin typeface="Arial"/>
                <a:cs typeface="Arial"/>
              </a:rPr>
              <a:t>100</a:t>
            </a:r>
            <a:r>
              <a:rPr dirty="0" sz="1400" spc="-55">
                <a:solidFill>
                  <a:srgbClr val="010202"/>
                </a:solidFill>
                <a:latin typeface="Arial"/>
                <a:cs typeface="Arial"/>
              </a:rPr>
              <a:t> </a:t>
            </a:r>
            <a:r>
              <a:rPr dirty="0" sz="1400" spc="-50">
                <a:solidFill>
                  <a:srgbClr val="010202"/>
                </a:solidFill>
                <a:latin typeface="Arial"/>
                <a:cs typeface="Arial"/>
              </a:rPr>
              <a:t>Å</a:t>
            </a:r>
            <a:endParaRPr sz="1400">
              <a:latin typeface="Arial"/>
              <a:cs typeface="Arial"/>
            </a:endParaRPr>
          </a:p>
        </p:txBody>
      </p:sp>
      <p:sp>
        <p:nvSpPr>
          <p:cNvPr id="20" name="object 20" descr=""/>
          <p:cNvSpPr txBox="1"/>
          <p:nvPr/>
        </p:nvSpPr>
        <p:spPr>
          <a:xfrm>
            <a:off x="701682" y="415559"/>
            <a:ext cx="12446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231F20"/>
                </a:solidFill>
                <a:latin typeface="Arial"/>
                <a:cs typeface="Arial"/>
              </a:rPr>
              <a:t>a</a:t>
            </a:r>
            <a:endParaRPr sz="1400">
              <a:latin typeface="Arial"/>
              <a:cs typeface="Arial"/>
            </a:endParaRPr>
          </a:p>
        </p:txBody>
      </p:sp>
      <p:sp>
        <p:nvSpPr>
          <p:cNvPr id="21" name="object 21" descr=""/>
          <p:cNvSpPr txBox="1"/>
          <p:nvPr/>
        </p:nvSpPr>
        <p:spPr>
          <a:xfrm>
            <a:off x="701711" y="3974707"/>
            <a:ext cx="142240" cy="276860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650" spc="-5">
                <a:solidFill>
                  <a:srgbClr val="231F20"/>
                </a:solidFill>
                <a:latin typeface="Arial"/>
                <a:cs typeface="Arial"/>
              </a:rPr>
              <a:t>b</a:t>
            </a:r>
            <a:endParaRPr sz="1650">
              <a:latin typeface="Arial"/>
              <a:cs typeface="Arial"/>
            </a:endParaRPr>
          </a:p>
        </p:txBody>
      </p:sp>
      <p:sp>
        <p:nvSpPr>
          <p:cNvPr id="22" name="object 22" descr=""/>
          <p:cNvSpPr txBox="1"/>
          <p:nvPr/>
        </p:nvSpPr>
        <p:spPr>
          <a:xfrm>
            <a:off x="4047087" y="3974707"/>
            <a:ext cx="130175" cy="276860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650" spc="-5">
                <a:solidFill>
                  <a:srgbClr val="231F20"/>
                </a:solidFill>
                <a:latin typeface="Arial"/>
                <a:cs typeface="Arial"/>
              </a:rPr>
              <a:t>c</a:t>
            </a:r>
            <a:endParaRPr sz="1650">
              <a:latin typeface="Arial"/>
              <a:cs typeface="Arial"/>
            </a:endParaRPr>
          </a:p>
        </p:txBody>
      </p:sp>
      <p:sp>
        <p:nvSpPr>
          <p:cNvPr id="23" name="object 23" descr=""/>
          <p:cNvSpPr txBox="1"/>
          <p:nvPr/>
        </p:nvSpPr>
        <p:spPr>
          <a:xfrm>
            <a:off x="967370" y="918720"/>
            <a:ext cx="1707514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231F20"/>
                </a:solidFill>
                <a:latin typeface="Trebuchet MS"/>
                <a:cs typeface="Trebuchet MS"/>
              </a:rPr>
              <a:t>KRAS-</a:t>
            </a:r>
            <a:r>
              <a:rPr dirty="0" sz="1000">
                <a:solidFill>
                  <a:srgbClr val="231F20"/>
                </a:solidFill>
                <a:latin typeface="Trebuchet MS"/>
                <a:cs typeface="Trebuchet MS"/>
              </a:rPr>
              <a:t>G12D</a:t>
            </a:r>
            <a:r>
              <a:rPr dirty="0" baseline="35353" sz="825">
                <a:solidFill>
                  <a:srgbClr val="231F20"/>
                </a:solidFill>
                <a:latin typeface="Trebuchet MS"/>
                <a:cs typeface="Trebuchet MS"/>
              </a:rPr>
              <a:t>GDP</a:t>
            </a:r>
            <a:r>
              <a:rPr dirty="0" baseline="35353" sz="825" spc="12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45">
                <a:solidFill>
                  <a:srgbClr val="231F20"/>
                </a:solidFill>
                <a:latin typeface="Trebuchet MS"/>
                <a:cs typeface="Trebuchet MS"/>
              </a:rPr>
              <a:t>X-</a:t>
            </a:r>
            <a:r>
              <a:rPr dirty="0" sz="1000" spc="-95">
                <a:solidFill>
                  <a:srgbClr val="231F20"/>
                </a:solidFill>
                <a:latin typeface="Trebuchet MS"/>
                <a:cs typeface="Trebuchet MS"/>
              </a:rPr>
              <a:t>ray,</a:t>
            </a:r>
            <a:r>
              <a:rPr dirty="0" sz="1000" spc="55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10">
                <a:solidFill>
                  <a:srgbClr val="231F20"/>
                </a:solidFill>
                <a:latin typeface="Trebuchet MS"/>
                <a:cs typeface="Trebuchet MS"/>
              </a:rPr>
              <a:t>PDB:5US4</a:t>
            </a:r>
            <a:endParaRPr sz="1000">
              <a:latin typeface="Trebuchet MS"/>
              <a:cs typeface="Trebuchet MS"/>
            </a:endParaRPr>
          </a:p>
        </p:txBody>
      </p:sp>
      <p:sp>
        <p:nvSpPr>
          <p:cNvPr id="24" name="object 24" descr=""/>
          <p:cNvSpPr txBox="1"/>
          <p:nvPr/>
        </p:nvSpPr>
        <p:spPr>
          <a:xfrm>
            <a:off x="2934652" y="757823"/>
            <a:ext cx="1707514" cy="452120"/>
          </a:xfrm>
          <a:prstGeom prst="rect">
            <a:avLst/>
          </a:prstGeom>
        </p:spPr>
        <p:txBody>
          <a:bodyPr wrap="square" lIns="0" tIns="7366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580"/>
              </a:spcBef>
            </a:pPr>
            <a:r>
              <a:rPr dirty="0" sz="1000" spc="-25">
                <a:solidFill>
                  <a:srgbClr val="231F20"/>
                </a:solidFill>
                <a:latin typeface="Trebuchet MS"/>
                <a:cs typeface="Trebuchet MS"/>
              </a:rPr>
              <a:t>KRAS-</a:t>
            </a:r>
            <a:r>
              <a:rPr dirty="0" sz="1000">
                <a:solidFill>
                  <a:srgbClr val="231F20"/>
                </a:solidFill>
                <a:latin typeface="Trebuchet MS"/>
                <a:cs typeface="Trebuchet MS"/>
              </a:rPr>
              <a:t>G12D</a:t>
            </a:r>
            <a:r>
              <a:rPr dirty="0" baseline="35353" sz="825">
                <a:solidFill>
                  <a:srgbClr val="231F20"/>
                </a:solidFill>
                <a:latin typeface="Trebuchet MS"/>
                <a:cs typeface="Trebuchet MS"/>
              </a:rPr>
              <a:t>GDP</a:t>
            </a:r>
            <a:r>
              <a:rPr dirty="0" baseline="35353" sz="825" spc="12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45">
                <a:solidFill>
                  <a:srgbClr val="231F20"/>
                </a:solidFill>
                <a:latin typeface="Trebuchet MS"/>
                <a:cs typeface="Trebuchet MS"/>
              </a:rPr>
              <a:t>X-</a:t>
            </a:r>
            <a:r>
              <a:rPr dirty="0" sz="1000" spc="-95">
                <a:solidFill>
                  <a:srgbClr val="231F20"/>
                </a:solidFill>
                <a:latin typeface="Trebuchet MS"/>
                <a:cs typeface="Trebuchet MS"/>
              </a:rPr>
              <a:t>ray,</a:t>
            </a:r>
            <a:r>
              <a:rPr dirty="0" sz="1000" spc="55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10">
                <a:solidFill>
                  <a:srgbClr val="231F20"/>
                </a:solidFill>
                <a:latin typeface="Trebuchet MS"/>
                <a:cs typeface="Trebuchet MS"/>
              </a:rPr>
              <a:t>PDB:5US4</a:t>
            </a:r>
            <a:endParaRPr sz="1000">
              <a:latin typeface="Trebuchet MS"/>
              <a:cs typeface="Trebuchet MS"/>
            </a:endParaRPr>
          </a:p>
          <a:p>
            <a:pPr marL="38100">
              <a:lnSpc>
                <a:spcPct val="100000"/>
              </a:lnSpc>
              <a:spcBef>
                <a:spcPts val="480"/>
              </a:spcBef>
            </a:pPr>
            <a:r>
              <a:rPr dirty="0" sz="1000" spc="-20">
                <a:solidFill>
                  <a:srgbClr val="231F20"/>
                </a:solidFill>
                <a:latin typeface="Trebuchet MS"/>
                <a:cs typeface="Trebuchet MS"/>
              </a:rPr>
              <a:t>100ns</a:t>
            </a:r>
            <a:r>
              <a:rPr dirty="0" sz="1000" spc="-5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70">
                <a:solidFill>
                  <a:srgbClr val="231F20"/>
                </a:solidFill>
                <a:latin typeface="Trebuchet MS"/>
                <a:cs typeface="Trebuchet MS"/>
              </a:rPr>
              <a:t>MD</a:t>
            </a:r>
            <a:r>
              <a:rPr dirty="0" sz="1000" spc="-5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60">
                <a:solidFill>
                  <a:srgbClr val="231F20"/>
                </a:solidFill>
                <a:latin typeface="Trebuchet MS"/>
                <a:cs typeface="Trebuchet MS"/>
              </a:rPr>
              <a:t>trajectory</a:t>
            </a:r>
            <a:r>
              <a:rPr dirty="0" sz="1000" spc="-5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20">
                <a:solidFill>
                  <a:srgbClr val="231F20"/>
                </a:solidFill>
                <a:latin typeface="Trebuchet MS"/>
                <a:cs typeface="Trebuchet MS"/>
              </a:rPr>
              <a:t>frame</a:t>
            </a:r>
            <a:endParaRPr sz="1000">
              <a:latin typeface="Trebuchet MS"/>
              <a:cs typeface="Trebuchet MS"/>
            </a:endParaRPr>
          </a:p>
        </p:txBody>
      </p:sp>
      <p:sp>
        <p:nvSpPr>
          <p:cNvPr id="25" name="object 25" descr=""/>
          <p:cNvSpPr txBox="1"/>
          <p:nvPr/>
        </p:nvSpPr>
        <p:spPr>
          <a:xfrm>
            <a:off x="4929609" y="918720"/>
            <a:ext cx="170180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1000" spc="-25">
                <a:solidFill>
                  <a:srgbClr val="231F20"/>
                </a:solidFill>
                <a:latin typeface="Trebuchet MS"/>
                <a:cs typeface="Trebuchet MS"/>
              </a:rPr>
              <a:t>KRAS-</a:t>
            </a:r>
            <a:r>
              <a:rPr dirty="0" sz="1000">
                <a:solidFill>
                  <a:srgbClr val="231F20"/>
                </a:solidFill>
                <a:latin typeface="Trebuchet MS"/>
                <a:cs typeface="Trebuchet MS"/>
              </a:rPr>
              <a:t>G12D</a:t>
            </a:r>
            <a:r>
              <a:rPr dirty="0" baseline="35353" sz="825">
                <a:solidFill>
                  <a:srgbClr val="231F20"/>
                </a:solidFill>
                <a:latin typeface="Trebuchet MS"/>
                <a:cs typeface="Trebuchet MS"/>
              </a:rPr>
              <a:t>GCP</a:t>
            </a:r>
            <a:r>
              <a:rPr dirty="0" baseline="35353" sz="825" spc="97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45">
                <a:solidFill>
                  <a:srgbClr val="231F20"/>
                </a:solidFill>
                <a:latin typeface="Trebuchet MS"/>
                <a:cs typeface="Trebuchet MS"/>
              </a:rPr>
              <a:t>X-</a:t>
            </a:r>
            <a:r>
              <a:rPr dirty="0" sz="1000" spc="-95">
                <a:solidFill>
                  <a:srgbClr val="231F20"/>
                </a:solidFill>
                <a:latin typeface="Trebuchet MS"/>
                <a:cs typeface="Trebuchet MS"/>
              </a:rPr>
              <a:t>ray,</a:t>
            </a:r>
            <a:r>
              <a:rPr dirty="0" sz="1000" spc="30">
                <a:solidFill>
                  <a:srgbClr val="231F20"/>
                </a:solidFill>
                <a:latin typeface="Trebuchet MS"/>
                <a:cs typeface="Trebuchet MS"/>
              </a:rPr>
              <a:t> </a:t>
            </a:r>
            <a:r>
              <a:rPr dirty="0" sz="1000" spc="-10">
                <a:solidFill>
                  <a:srgbClr val="231F20"/>
                </a:solidFill>
                <a:latin typeface="Trebuchet MS"/>
                <a:cs typeface="Trebuchet MS"/>
              </a:rPr>
              <a:t>PDB:4DST</a:t>
            </a:r>
            <a:endParaRPr sz="1000">
              <a:latin typeface="Trebuchet MS"/>
              <a:cs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3</dc:title>
  <dcterms:created xsi:type="dcterms:W3CDTF">2023-11-08T04:09:36Z</dcterms:created>
  <dcterms:modified xsi:type="dcterms:W3CDTF">2023-11-08T04:09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10-30T00:00:00Z</vt:filetime>
  </property>
  <property fmtid="{D5CDD505-2E9C-101B-9397-08002B2CF9AE}" pid="3" name="Creator">
    <vt:lpwstr>Adobe Illustrator 26.0 (Macintosh)</vt:lpwstr>
  </property>
  <property fmtid="{D5CDD505-2E9C-101B-9397-08002B2CF9AE}" pid="4" name="LastSaved">
    <vt:filetime>2023-11-08T00:00:00Z</vt:filetime>
  </property>
  <property fmtid="{D5CDD505-2E9C-101B-9397-08002B2CF9AE}" pid="5" name="Producer">
    <vt:lpwstr>Adobe PDF library 16.03</vt:lpwstr>
  </property>
</Properties>
</file>